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018" autoAdjust="0"/>
    <p:restoredTop sz="94660"/>
  </p:normalViewPr>
  <p:slideViewPr>
    <p:cSldViewPr snapToGrid="0">
      <p:cViewPr varScale="1">
        <p:scale>
          <a:sx n="117" d="100"/>
          <a:sy n="117" d="100"/>
        </p:scale>
        <p:origin x="12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AEC33AD-2348-71E4-AA29-270FDCE50AC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92CEC039-DA0B-9C2E-B061-EFF7F5D11E3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AB29B4F-9E37-9158-05D1-EBB627C5D9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DB1F0-0985-4132-AF03-DFEC9633614B}" type="datetimeFigureOut">
              <a:rPr kumimoji="1" lang="ja-JP" altLang="en-US" smtClean="0"/>
              <a:t>2025/1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89D64A5-CC84-0D66-0CC5-67691D1CE8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8E65EF7-066E-A661-246C-A0BD9E8084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9DF71-39F6-4495-B65D-0CF3A1D9DA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52731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C972CEC-CF8B-B617-3840-3A3867D6D7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A1D8333-FBC4-7E3E-3394-20650C704E1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E86BBC9-74B4-97CF-5F12-D364DD0DCD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DB1F0-0985-4132-AF03-DFEC9633614B}" type="datetimeFigureOut">
              <a:rPr kumimoji="1" lang="ja-JP" altLang="en-US" smtClean="0"/>
              <a:t>2025/1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B04EA2A-DD1A-98A8-3B09-F694D9116B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A3D414B-0DCE-8656-0945-979248E3F4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9DF71-39F6-4495-B65D-0CF3A1D9DA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36864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A94DB391-02FF-98DA-34B9-D56BC56D62B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93B0B06-3528-B8CF-8D66-CC6BE9163C6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CAFE3CA-091D-391D-2D22-5A3BEF1B90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DB1F0-0985-4132-AF03-DFEC9633614B}" type="datetimeFigureOut">
              <a:rPr kumimoji="1" lang="ja-JP" altLang="en-US" smtClean="0"/>
              <a:t>2025/1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8100E23-599F-82CD-99D7-4AF2E4B157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9AA5535-6B1C-7D0D-884F-339073B92E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9DF71-39F6-4495-B65D-0CF3A1D9DA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83239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CD6C941-FE9D-84C0-7548-77D1358202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60C1C3C-C5D7-85B2-1BD3-162C7DAF2D9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8258824-E5FE-FE84-CF9A-D513003B4B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DB1F0-0985-4132-AF03-DFEC9633614B}" type="datetimeFigureOut">
              <a:rPr kumimoji="1" lang="ja-JP" altLang="en-US" smtClean="0"/>
              <a:t>2025/1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3453D8F-16A4-CC3B-B1A1-892FDAAA80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B46E6F5-EEF0-80D7-9423-465AE6C932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9DF71-39F6-4495-B65D-0CF3A1D9DA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96292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22CEBA8-738F-785C-8669-2B9F7B77DD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3872487-4CE5-0C74-AABF-5A805C3B4C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926E39E-1F77-CEC3-D1C2-B7E006F50D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DB1F0-0985-4132-AF03-DFEC9633614B}" type="datetimeFigureOut">
              <a:rPr kumimoji="1" lang="ja-JP" altLang="en-US" smtClean="0"/>
              <a:t>2025/1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63211D0-7A93-81E9-FDB7-977A42F440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6AC4642-0E59-AC79-BA91-EEDAB5F5CE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9DF71-39F6-4495-B65D-0CF3A1D9DA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56823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D06F7EC-439A-906B-43CD-001FEC17ED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FA019AC-158C-4428-BAFC-D99626E8F78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80DB780-1CD1-B487-3CA6-7D8E718F423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8306C9F-8C94-F4C2-683E-89902368DF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DB1F0-0985-4132-AF03-DFEC9633614B}" type="datetimeFigureOut">
              <a:rPr kumimoji="1" lang="ja-JP" altLang="en-US" smtClean="0"/>
              <a:t>2025/1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5690194-361A-E118-01AC-645073EF23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69EB0B2-5AC8-640A-E745-6504231036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9DF71-39F6-4495-B65D-0CF3A1D9DA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60926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E069CE7-6BBD-5FC8-CF40-342F622CCB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54EA5C2-720F-D3FA-37F3-F25CC95892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32C0762-E9C6-1E83-CAD0-06B65B1485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1E12C137-9594-6CFB-16E7-20D0CBCA7AD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F55CD878-B746-1C61-D7C6-6ECCCAF7FF4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C9291071-9DB1-54EF-B81B-8AC21438D1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DB1F0-0985-4132-AF03-DFEC9633614B}" type="datetimeFigureOut">
              <a:rPr kumimoji="1" lang="ja-JP" altLang="en-US" smtClean="0"/>
              <a:t>2025/1/2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4F544B1C-9482-3201-6259-3B0AFF5DFB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A2E6F720-A2F1-F631-2DE8-BD2D83EF8B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9DF71-39F6-4495-B65D-0CF3A1D9DA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03073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ADDF090-ED4E-ACA8-941F-42DF46A110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B3190ADA-4D67-DE83-7744-1994D4268E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DB1F0-0985-4132-AF03-DFEC9633614B}" type="datetimeFigureOut">
              <a:rPr kumimoji="1" lang="ja-JP" altLang="en-US" smtClean="0"/>
              <a:t>2025/1/2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0EB431C5-7F4A-C7A6-2E15-121C3E4285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0D7E43C5-00A8-81C7-A243-1F811B2F42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9DF71-39F6-4495-B65D-0CF3A1D9DA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37302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AAB9CB15-4F27-2AED-FE15-D39045C3A4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DB1F0-0985-4132-AF03-DFEC9633614B}" type="datetimeFigureOut">
              <a:rPr kumimoji="1" lang="ja-JP" altLang="en-US" smtClean="0"/>
              <a:t>2025/1/2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192E302-0674-32CC-291D-8D23E25540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768B9816-866C-EB6F-D121-72C5CAA719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9DF71-39F6-4495-B65D-0CF3A1D9DA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92478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9270177-710D-8989-D2A7-46FFC6DCE7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67280C0-D551-D42F-7767-2AEFD90BAA0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2556B1E9-856D-7F8B-4C53-033ABE7646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A1B4625-6E5A-27ED-7111-32B52987EA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DB1F0-0985-4132-AF03-DFEC9633614B}" type="datetimeFigureOut">
              <a:rPr kumimoji="1" lang="ja-JP" altLang="en-US" smtClean="0"/>
              <a:t>2025/1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2670000-1396-EE17-8E17-460043DDEA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72942D7-381C-7037-9839-CDD21B1ECF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9DF71-39F6-4495-B65D-0CF3A1D9DA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8097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E5C8360-3119-FA6F-5450-8EE16D97C1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181BD345-FDA7-6C66-B991-FC673B65068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0000F09-9E39-08A0-2C66-5FC14EE10C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60CDAAC-041E-F11E-8E3E-54A47830B2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DB1F0-0985-4132-AF03-DFEC9633614B}" type="datetimeFigureOut">
              <a:rPr kumimoji="1" lang="ja-JP" altLang="en-US" smtClean="0"/>
              <a:t>2025/1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3BAA6E0-4D6B-3FCD-7D84-1ABC66065F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62F5A94-63F9-DD5E-48CE-74D2220D73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9DF71-39F6-4495-B65D-0CF3A1D9DA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87306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0C0CBBF2-AE5B-1A50-6C5F-53A1BCB4B4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0017A97-DD55-94BD-1597-25B4C22BAC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99703F3-75C7-C852-7A1B-8C615ABC87E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8DB1F0-0985-4132-AF03-DFEC9633614B}" type="datetimeFigureOut">
              <a:rPr kumimoji="1" lang="ja-JP" altLang="en-US" smtClean="0"/>
              <a:t>2025/1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A8FDE9D-7D4B-13D4-3A92-2B0B924ED35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C7DE262-3020-53FC-3533-BA95703F000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B9DF71-39F6-4495-B65D-0CF3A1D9DA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66893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図 23">
            <a:extLst>
              <a:ext uri="{FF2B5EF4-FFF2-40B4-BE49-F238E27FC236}">
                <a16:creationId xmlns:a16="http://schemas.microsoft.com/office/drawing/2014/main" id="{D0629EEB-10F6-E54C-CD1B-CB3EBE2181B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04352" y="604844"/>
            <a:ext cx="4797994" cy="3119939"/>
          </a:xfrm>
          <a:prstGeom prst="rect">
            <a:avLst/>
          </a:prstGeom>
        </p:spPr>
      </p:pic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33F8E1F3-F5EA-0217-A348-BAF08348262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05149391"/>
              </p:ext>
            </p:extLst>
          </p:nvPr>
        </p:nvGraphicFramePr>
        <p:xfrm>
          <a:off x="2209439" y="4570435"/>
          <a:ext cx="7529385" cy="17373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509795">
                  <a:extLst>
                    <a:ext uri="{9D8B030D-6E8A-4147-A177-3AD203B41FA5}">
                      <a16:colId xmlns:a16="http://schemas.microsoft.com/office/drawing/2014/main" val="1375256391"/>
                    </a:ext>
                  </a:extLst>
                </a:gridCol>
                <a:gridCol w="2509795">
                  <a:extLst>
                    <a:ext uri="{9D8B030D-6E8A-4147-A177-3AD203B41FA5}">
                      <a16:colId xmlns:a16="http://schemas.microsoft.com/office/drawing/2014/main" val="2999768681"/>
                    </a:ext>
                  </a:extLst>
                </a:gridCol>
                <a:gridCol w="2509795">
                  <a:extLst>
                    <a:ext uri="{9D8B030D-6E8A-4147-A177-3AD203B41FA5}">
                      <a16:colId xmlns:a16="http://schemas.microsoft.com/office/drawing/2014/main" val="1408386092"/>
                    </a:ext>
                  </a:extLst>
                </a:gridCol>
              </a:tblGrid>
              <a:tr h="344421">
                <a:tc>
                  <a:txBody>
                    <a:bodyPr/>
                    <a:lstStyle/>
                    <a:p>
                      <a:pPr algn="ctr"/>
                      <a:endParaRPr kumimoji="1" lang="ja-JP" altLang="en-US" sz="1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peat OP</a:t>
                      </a:r>
                      <a:endParaRPr kumimoji="1" lang="ja-JP" altLang="en-US" sz="1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-repeat OP</a:t>
                      </a:r>
                      <a:endParaRPr kumimoji="1" lang="ja-JP" altLang="en-US" sz="1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46686792"/>
                  </a:ext>
                </a:extLst>
              </a:tr>
              <a:tr h="34442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OS, months </a:t>
                      </a:r>
                    </a:p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5% CI)</a:t>
                      </a:r>
                      <a:endParaRPr kumimoji="1" lang="ja-JP" altLang="en-US" sz="1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.1</a:t>
                      </a:r>
                    </a:p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27.9-NR)</a:t>
                      </a:r>
                      <a:endParaRPr kumimoji="1" lang="ja-JP" altLang="en-US" sz="1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.5</a:t>
                      </a:r>
                    </a:p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4.3-36.9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450245"/>
                  </a:ext>
                </a:extLst>
              </a:tr>
              <a:tr h="34442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 (95% CI)</a:t>
                      </a:r>
                      <a:endParaRPr kumimoji="1" lang="ja-JP" altLang="en-US" sz="1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5 (0.29-1.04)</a:t>
                      </a:r>
                      <a:endParaRPr kumimoji="1" lang="ja-JP" altLang="en-US" sz="1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61474425"/>
                  </a:ext>
                </a:extLst>
              </a:tr>
              <a:tr h="34442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kumimoji="1" lang="ja-JP" altLang="en-US" sz="1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6</a:t>
                      </a:r>
                      <a:endParaRPr kumimoji="1" lang="ja-JP" altLang="en-US" sz="1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kumimoji="1" lang="en-US" altLang="ja-JP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56430287"/>
                  </a:ext>
                </a:extLst>
              </a:tr>
            </a:tbl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24674E7E-EC72-1179-CF87-641591098A77}"/>
              </a:ext>
            </a:extLst>
          </p:cNvPr>
          <p:cNvSpPr txBox="1"/>
          <p:nvPr/>
        </p:nvSpPr>
        <p:spPr>
          <a:xfrm>
            <a:off x="6916708" y="966708"/>
            <a:ext cx="27008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epeat OP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4AC3BC0-A3C8-8B71-B307-EF1FB368BCB5}"/>
              </a:ext>
            </a:extLst>
          </p:cNvPr>
          <p:cNvSpPr txBox="1"/>
          <p:nvPr/>
        </p:nvSpPr>
        <p:spPr>
          <a:xfrm>
            <a:off x="6923685" y="1309739"/>
            <a:ext cx="2628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Non-repeat OP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77CDF533-BDB2-36A3-46F7-0BBBF7CDE2B7}"/>
              </a:ext>
            </a:extLst>
          </p:cNvPr>
          <p:cNvCxnSpPr>
            <a:cxnSpLocks/>
          </p:cNvCxnSpPr>
          <p:nvPr/>
        </p:nvCxnSpPr>
        <p:spPr>
          <a:xfrm>
            <a:off x="6539101" y="1155567"/>
            <a:ext cx="377607" cy="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FCB64746-BC55-CAF9-5A07-056A6872519C}"/>
              </a:ext>
            </a:extLst>
          </p:cNvPr>
          <p:cNvCxnSpPr>
            <a:cxnSpLocks/>
          </p:cNvCxnSpPr>
          <p:nvPr/>
        </p:nvCxnSpPr>
        <p:spPr>
          <a:xfrm>
            <a:off x="6539101" y="1479120"/>
            <a:ext cx="377607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03BA5D3-1E79-14BF-535D-9FEE321BF124}"/>
              </a:ext>
            </a:extLst>
          </p:cNvPr>
          <p:cNvSpPr txBox="1"/>
          <p:nvPr/>
        </p:nvSpPr>
        <p:spPr>
          <a:xfrm>
            <a:off x="4467839" y="3505679"/>
            <a:ext cx="5445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36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0D8F00E-D8CF-75E7-2E1F-FBFAE405120E}"/>
              </a:ext>
            </a:extLst>
          </p:cNvPr>
          <p:cNvSpPr txBox="1"/>
          <p:nvPr/>
        </p:nvSpPr>
        <p:spPr>
          <a:xfrm>
            <a:off x="4466630" y="3853774"/>
            <a:ext cx="4083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B270BB71-F2A3-39A5-D7A9-BF3D478AB1E5}"/>
              </a:ext>
            </a:extLst>
          </p:cNvPr>
          <p:cNvSpPr txBox="1"/>
          <p:nvPr/>
        </p:nvSpPr>
        <p:spPr>
          <a:xfrm>
            <a:off x="5054264" y="3505679"/>
            <a:ext cx="4163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22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8A95F732-DDBF-EBC4-E387-06638FE20A29}"/>
              </a:ext>
            </a:extLst>
          </p:cNvPr>
          <p:cNvSpPr txBox="1"/>
          <p:nvPr/>
        </p:nvSpPr>
        <p:spPr>
          <a:xfrm>
            <a:off x="5639113" y="3505678"/>
            <a:ext cx="3907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1477F43B-4975-ED03-15F1-5CE49B92F1C0}"/>
              </a:ext>
            </a:extLst>
          </p:cNvPr>
          <p:cNvSpPr txBox="1"/>
          <p:nvPr/>
        </p:nvSpPr>
        <p:spPr>
          <a:xfrm>
            <a:off x="6875459" y="3505678"/>
            <a:ext cx="2884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8FC9C2AA-E139-A100-E462-F3973747EDFE}"/>
              </a:ext>
            </a:extLst>
          </p:cNvPr>
          <p:cNvSpPr txBox="1"/>
          <p:nvPr/>
        </p:nvSpPr>
        <p:spPr>
          <a:xfrm>
            <a:off x="7466475" y="3497365"/>
            <a:ext cx="2884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7597E6F1-68D2-9BCD-4720-C6404DBFC248}"/>
              </a:ext>
            </a:extLst>
          </p:cNvPr>
          <p:cNvSpPr txBox="1"/>
          <p:nvPr/>
        </p:nvSpPr>
        <p:spPr>
          <a:xfrm>
            <a:off x="5048528" y="3853775"/>
            <a:ext cx="3809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22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C3C41CB6-2D3A-7CCF-8A31-2E585064A2F5}"/>
              </a:ext>
            </a:extLst>
          </p:cNvPr>
          <p:cNvSpPr txBox="1"/>
          <p:nvPr/>
        </p:nvSpPr>
        <p:spPr>
          <a:xfrm>
            <a:off x="6262200" y="3853775"/>
            <a:ext cx="4498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C911FAE6-11F8-6339-F480-EBF6D4CFC7FF}"/>
              </a:ext>
            </a:extLst>
          </p:cNvPr>
          <p:cNvSpPr txBox="1"/>
          <p:nvPr/>
        </p:nvSpPr>
        <p:spPr>
          <a:xfrm>
            <a:off x="6881676" y="3853775"/>
            <a:ext cx="4544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CA23298A-A4DD-6708-D3BA-416F37CDAFFB}"/>
              </a:ext>
            </a:extLst>
          </p:cNvPr>
          <p:cNvSpPr txBox="1"/>
          <p:nvPr/>
        </p:nvSpPr>
        <p:spPr>
          <a:xfrm>
            <a:off x="7474639" y="3853774"/>
            <a:ext cx="3597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2248FDB9-09C3-8B17-644C-C504B4AC2198}"/>
              </a:ext>
            </a:extLst>
          </p:cNvPr>
          <p:cNvSpPr txBox="1"/>
          <p:nvPr/>
        </p:nvSpPr>
        <p:spPr>
          <a:xfrm>
            <a:off x="2768571" y="3209330"/>
            <a:ext cx="15207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u="sng" dirty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  <a:endParaRPr lang="ja-JP" altLang="en-US" sz="14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0CB66A20-E866-6E11-3B88-FF3EFF09EFB6}"/>
              </a:ext>
            </a:extLst>
          </p:cNvPr>
          <p:cNvSpPr txBox="1"/>
          <p:nvPr/>
        </p:nvSpPr>
        <p:spPr>
          <a:xfrm>
            <a:off x="3138030" y="3504894"/>
            <a:ext cx="11074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u="sng" dirty="0">
                <a:latin typeface="Arial" panose="020B0604020202020204" pitchFamily="34" charset="0"/>
                <a:cs typeface="Arial" panose="020B0604020202020204" pitchFamily="34" charset="0"/>
              </a:rPr>
              <a:t>Repeat OP</a:t>
            </a:r>
            <a:endParaRPr lang="ja-JP" altLang="en-US" sz="14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13723F84-2FF3-C145-061A-6511A886D8BA}"/>
              </a:ext>
            </a:extLst>
          </p:cNvPr>
          <p:cNvSpPr txBox="1"/>
          <p:nvPr/>
        </p:nvSpPr>
        <p:spPr>
          <a:xfrm>
            <a:off x="2787113" y="3853433"/>
            <a:ext cx="15207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u="sng" dirty="0">
                <a:latin typeface="Arial" panose="020B0604020202020204" pitchFamily="34" charset="0"/>
                <a:cs typeface="Arial" panose="020B0604020202020204" pitchFamily="34" charset="0"/>
              </a:rPr>
              <a:t>Non-repeat OP</a:t>
            </a:r>
            <a:endParaRPr lang="ja-JP" altLang="en-US" sz="14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9DD73E6F-2CF8-2CD1-A72A-C380032C65EA}"/>
              </a:ext>
            </a:extLst>
          </p:cNvPr>
          <p:cNvSpPr txBox="1"/>
          <p:nvPr/>
        </p:nvSpPr>
        <p:spPr>
          <a:xfrm>
            <a:off x="6260415" y="3502956"/>
            <a:ext cx="2884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7A38F167-C479-BCCD-9DB1-2F96A04B4A2A}"/>
              </a:ext>
            </a:extLst>
          </p:cNvPr>
          <p:cNvSpPr txBox="1"/>
          <p:nvPr/>
        </p:nvSpPr>
        <p:spPr>
          <a:xfrm>
            <a:off x="5696148" y="3859217"/>
            <a:ext cx="4498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280BF2CA-28FA-B385-15F5-BF55A4CA4C61}"/>
              </a:ext>
            </a:extLst>
          </p:cNvPr>
          <p:cNvSpPr txBox="1"/>
          <p:nvPr/>
        </p:nvSpPr>
        <p:spPr>
          <a:xfrm>
            <a:off x="4465093" y="4173883"/>
            <a:ext cx="34572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u="sng" dirty="0">
                <a:latin typeface="Arial" panose="020B0604020202020204" pitchFamily="34" charset="0"/>
                <a:cs typeface="Arial" panose="020B0604020202020204" pitchFamily="34" charset="0"/>
              </a:rPr>
              <a:t>OP-OS</a:t>
            </a:r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1">
            <a:extLst>
              <a:ext uri="{FF2B5EF4-FFF2-40B4-BE49-F238E27FC236}">
                <a16:creationId xmlns:a16="http://schemas.microsoft.com/office/drawing/2014/main" id="{24305716-DEF0-8E02-7D80-7BC1F8B88E8B}"/>
              </a:ext>
            </a:extLst>
          </p:cNvPr>
          <p:cNvSpPr txBox="1"/>
          <p:nvPr/>
        </p:nvSpPr>
        <p:spPr>
          <a:xfrm>
            <a:off x="934445" y="420178"/>
            <a:ext cx="27008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upplemental Figure 4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895965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</TotalTime>
  <Words>60</Words>
  <Application>Microsoft Office PowerPoint</Application>
  <PresentationFormat>ワイド画面</PresentationFormat>
  <Paragraphs>3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大亮 森永</dc:creator>
  <cp:lastModifiedBy>大亮 森永</cp:lastModifiedBy>
  <cp:revision>9</cp:revision>
  <dcterms:created xsi:type="dcterms:W3CDTF">2024-11-20T06:26:24Z</dcterms:created>
  <dcterms:modified xsi:type="dcterms:W3CDTF">2025-01-22T07:45:04Z</dcterms:modified>
</cp:coreProperties>
</file>